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25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00B7E-68D3-4739-8116-2D860BE9FA01}" type="datetimeFigureOut">
              <a:rPr lang="en-US" smtClean="0"/>
              <a:pPr/>
              <a:t>8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oup 35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1494796"/>
              </p:ext>
            </p:extLst>
          </p:nvPr>
        </p:nvGraphicFramePr>
        <p:xfrm>
          <a:off x="838200" y="2209800"/>
          <a:ext cx="7467600" cy="2726362"/>
        </p:xfrm>
        <a:graphic>
          <a:graphicData uri="http://schemas.openxmlformats.org/drawingml/2006/table">
            <a:tbl>
              <a:tblPr/>
              <a:tblGrid>
                <a:gridCol w="933450"/>
                <a:gridCol w="1809750"/>
                <a:gridCol w="1371600"/>
                <a:gridCol w="914400"/>
                <a:gridCol w="1676400"/>
                <a:gridCol w="762000"/>
              </a:tblGrid>
              <a:tr h="40550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ell lin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ite of Origin in Patient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etastasis Status of the Patient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orm Tumor in </a:t>
                      </a:r>
                      <a:r>
                        <a:rPr kumimoji="0" lang="en-US" sz="10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Xenograft</a:t>
                      </a:r>
                      <a:endPara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etastasize to Neck Lymph node in </a:t>
                      </a:r>
                      <a:r>
                        <a:rPr kumimoji="0" lang="en-US" sz="10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Xenograft</a:t>
                      </a:r>
                      <a:endPara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53</a:t>
                      </a: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statu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9908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JHU-019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ongu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uta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084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M-SCC-14A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Floor of mouth (1st recurrence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ega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uta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0470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M-SCC-14C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rd recurrence, after chemo/ radiation therap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ega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t Tes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uta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77893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CI-15A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ral cavit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uta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62653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CI-15B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rd recurrence, after chemo/ radiation therap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uta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9811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M-SCC-17A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Larynx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ega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t Tes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t Tes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ild-typ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9811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UM-SCC-47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Oral cavit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ve Lymph No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t Tes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t Tested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ild-typ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62000" y="1749623"/>
            <a:ext cx="6098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able S4. Characteristics of the OSCC cell lines used for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functional screens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122</Words>
  <Application>Microsoft Office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Xu, Chang</cp:lastModifiedBy>
  <cp:revision>38</cp:revision>
  <dcterms:created xsi:type="dcterms:W3CDTF">2011-06-08T23:30:32Z</dcterms:created>
  <dcterms:modified xsi:type="dcterms:W3CDTF">2012-08-21T03:15:50Z</dcterms:modified>
</cp:coreProperties>
</file>